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75E406-83C3-F089-4FEF-E1CD2E84D0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3421399-AFBA-6085-576F-44B506AF6A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77771B-1665-DDBE-C055-F29608DDD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3DA9CF9-A3EF-CB03-C626-CEA781F3C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3A0EC5-3C43-71EC-1F92-A3E77E79F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8610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0C9BBF-D54F-72B3-B545-D2A8DEF6E6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9EBFAF9-8EED-72EA-620C-4E6BB984C2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CA2071-3540-2265-E713-B833D1433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DED9FF-72B3-13E4-8306-6E28498BB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4A426F-9BD5-B9B0-9520-DD4D25478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2314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D4633DF-AC63-0001-861D-200CF92800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C920E9-56C1-1F21-B43F-5299E3E2DB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98AD11-1F49-97C3-7AFF-A30467DF5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F119D4-9E91-7DE6-2C06-F19D8CB49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FBB4FE-48C5-3907-A309-00B2C136F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9258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633CE2-FD8F-4B47-16BE-BF91DB998D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53F1474-D0C9-338F-9D8C-A49DD58C96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8A1A33-8BFC-889B-7A61-186C3BFA4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8B0295-89F0-18AD-A1A9-2FD7766FA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81949E-59D6-93C3-CBB7-52022453B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656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337DC8-4F33-3E82-F89A-3671AD3522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3642F7A-B9A1-9CB7-1CFF-2A9C62F209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3608ED-394D-940B-C3BC-FC56B5DBF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5B0F70-A0EE-C685-53F4-C5F8A650C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E40A94-8D88-3153-14A4-61A8E3D08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18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8E128E-7EA4-76C7-DB04-947F62643F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01A312-E40F-A2B7-45E6-29C9FC9C27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F885CE2-E9B6-2CC7-BBB4-BC8A92671B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26E5546-F03D-1FF1-AF86-083D48AF7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79A25B-BE2D-7093-CB2C-A104ABCA7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9CBC296-43B0-0153-50AA-274A1C43C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566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F8ACA9-3A94-65F1-ED77-69BE6B770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C560AE1-C81E-19D6-C1A1-2833DA9D26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EAA1601-A8F5-4402-A116-671D34B20D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893CB37-F592-2B08-C6F3-6357FCA298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ABEBFC7-27D9-F787-B458-EFF5CD82BC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9E1A005-4F05-4578-10D4-29FC9C5F4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C6CD504-ED01-2A83-B1F9-F29A68090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CBD3905-D9E9-2DAD-BF90-04231FDDA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9605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3D4412-FA40-1F12-F8C8-0A4AB880BF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00F9C24-61FD-5B81-5562-5424FF2B1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CCA3E69-4E2D-1ED0-8AD0-4358C9823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B05F52E-633B-374D-B745-A13274946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198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AE15B80-5AFF-8612-E97B-88353DC27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DBCC27B-4D66-89D9-BECF-0D05FA19F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810AD21-7BC4-2F9D-1769-CAEA232DA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063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E0E379-1625-916E-603E-B22E9B3ED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7FB2BD3-214A-2619-3F73-C4876329C4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C18AB88-7F96-468D-E85C-6B9C58C12A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096D957-007A-82A9-9743-CB5C1A48D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9B3E7DC-AD44-D57E-7DA4-43AE0A259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11F26A-E51B-4CC3-AEA0-2D719A009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540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3B8A9E-DC76-D810-33BC-0B93A439A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7EE1C6F-542A-6166-42AA-A134B102A5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8548C20-C281-B4DB-B11D-B600CCC667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C99056-8773-EC8F-9E33-5EAFCB69F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94BF79-009F-44E9-7F98-BEE282106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D86B5A0-4B04-6B84-26CE-03C5F485A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680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9DAB306-C476-06E0-C3FA-7CBF30E99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70DEF68-A714-E8D7-9710-056953EB96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449F54-9C81-DF73-DBEC-8ACDD1BB58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6CB3A4-CB83-4982-98A4-1F43C1544A2A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2C7810-3680-7A9C-6492-8F88FC7D21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14A6B6-9334-97BF-9644-77EEB8D4F1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FD7FD8-56A0-4258-827D-C39764B12F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711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5488D186-5690-71D6-8645-4E50129530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4229993"/>
              </p:ext>
            </p:extLst>
          </p:nvPr>
        </p:nvGraphicFramePr>
        <p:xfrm>
          <a:off x="996695" y="128016"/>
          <a:ext cx="10020953" cy="6360304"/>
        </p:xfrm>
        <a:graphic>
          <a:graphicData uri="http://schemas.openxmlformats.org/drawingml/2006/table">
            <a:tbl>
              <a:tblPr/>
              <a:tblGrid>
                <a:gridCol w="1278393">
                  <a:extLst>
                    <a:ext uri="{9D8B030D-6E8A-4147-A177-3AD203B41FA5}">
                      <a16:colId xmlns:a16="http://schemas.microsoft.com/office/drawing/2014/main" val="2549807754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2713963122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4198339916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1249486537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3099093557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3796964579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2929242888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222402511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2177421538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1011093391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3974374166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738249371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2144437756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1800179807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4074776752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2394990253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4210338998"/>
                    </a:ext>
                  </a:extLst>
                </a:gridCol>
              </a:tblGrid>
              <a:tr h="508339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Supplementally table 3. Association between the cumulative number of ACEs and risk of mortality after converting age into a squared term (Modified Poisson regression model n=13,174)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8664685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en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6577397"/>
                  </a:ext>
                </a:extLst>
              </a:tr>
              <a:tr h="2689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Number of ACEs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Crude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3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9859950"/>
                  </a:ext>
                </a:extLst>
              </a:tr>
              <a:tr h="2689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1680435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9254861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5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31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029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5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93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9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399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0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89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3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984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0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89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3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987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2430021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2+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2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47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037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9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35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284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9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76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2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426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93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77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3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460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6531189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Women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3437845"/>
                  </a:ext>
                </a:extLst>
              </a:tr>
              <a:tr h="2689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Number of ACEs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Crude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3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383953"/>
                  </a:ext>
                </a:extLst>
              </a:tr>
              <a:tr h="2689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IRR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95%CI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p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3679625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Ref.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8483858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44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2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72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000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2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3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45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02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9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0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42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044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9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41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04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2563087"/>
                  </a:ext>
                </a:extLst>
              </a:tr>
              <a:tr h="268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2+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06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75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50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734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9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65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31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658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8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56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8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278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81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56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1.18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0.272</a:t>
                      </a:r>
                    </a:p>
                  </a:txBody>
                  <a:tcPr marL="5935" marR="5935" marT="5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1715209"/>
                  </a:ext>
                </a:extLst>
              </a:tr>
              <a:tr h="520484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Note. Controlled for age, childhood economical hardship, height, education, equivalized income, longest occupation, smoing, drinking, Disease, depressive symptom, martial status, frequency of meeting friends, social participation, employment status.   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7716466"/>
                  </a:ext>
                </a:extLst>
              </a:tr>
              <a:tr h="268916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1F1F1F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Crude includes cumulative ACEs score 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687979"/>
                  </a:ext>
                </a:extLst>
              </a:tr>
              <a:tr h="520484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 1 Includes Crude Model and age and adverse childhood experiences (economic status in childhood, height, educational history) and socioeconomic status in old age (equivalized income, employment status).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131707"/>
                  </a:ext>
                </a:extLst>
              </a:tr>
              <a:tr h="537834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 2 includes Model 2 and health status in old age (hypertension, diabetes, dyslipidemia, heart disease, respiratory disease, cancer) and lifestyle (smoking and alcohol).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3139098"/>
                  </a:ext>
                </a:extLst>
              </a:tr>
              <a:tr h="508339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Model 3 includes Model 3 and social relationships in old age (social participation, frequency of interaction with friends, employment status, marital status). 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7106747"/>
                  </a:ext>
                </a:extLst>
              </a:tr>
              <a:tr h="268916">
                <a:tc gridSpan="11"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游ゴシック" panose="020B0400000000000000" pitchFamily="50" charset="-128"/>
                          <a:cs typeface="Times" panose="02020603050405020304" pitchFamily="18" charset="0"/>
                        </a:rPr>
                        <a:t>ACEs: Adverse Childhood Experiences, IRR: Incidence Rate Ratio, CI: Confidence Interval  </a:t>
                      </a: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游ゴシック" panose="020B0400000000000000" pitchFamily="50" charset="-128"/>
                        <a:cs typeface="Times" panose="02020603050405020304" pitchFamily="18" charset="0"/>
                      </a:endParaRPr>
                    </a:p>
                  </a:txBody>
                  <a:tcPr marL="5935" marR="5935" marT="59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394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9157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66</Words>
  <Application>Microsoft Office PowerPoint</Application>
  <PresentationFormat>ワイド画面</PresentationFormat>
  <Paragraphs>1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巌 千嶋</dc:creator>
  <cp:lastModifiedBy>巌 千嶋</cp:lastModifiedBy>
  <cp:revision>1</cp:revision>
  <dcterms:created xsi:type="dcterms:W3CDTF">2024-11-03T05:39:43Z</dcterms:created>
  <dcterms:modified xsi:type="dcterms:W3CDTF">2024-11-03T05:42:03Z</dcterms:modified>
</cp:coreProperties>
</file>